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8B53E3-9D0E-493F-8886-F3564C0CFBD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363556-B6B7-42EE-92CD-910A5E5D55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39AE6A-08CC-47CB-AEE3-BAC4FF110FC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081BB2-E647-4031-AE3C-9B6D8412399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44A5F7-D913-4C9B-863F-5E31B21837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38800B-C539-4A88-8EBE-4408DD2DAC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60E32E-A52F-4183-89B0-EA3851470A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C113C4-62AB-4413-A179-A79EB9466D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DD3412-4DFB-499B-9DD3-191A835E9A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368A48-84A8-4CB1-A1E0-CE32EF53C8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517299-2512-467F-BA0D-337351D533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507427-46B1-4732-8321-089BAB7829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4FC43A-BEB1-4C0B-B11C-1544A845FDE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311040" y="228600"/>
            <a:ext cx="1468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2"/>
          <p:cNvSpPr/>
          <p:nvPr/>
        </p:nvSpPr>
        <p:spPr>
          <a:xfrm>
            <a:off x="769320" y="4354560"/>
            <a:ext cx="4385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able S1. Primer sequences used for qRT-P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533520" y="838080"/>
          <a:ext cx="5410080" cy="3438720"/>
        </p:xfrm>
        <a:graphic>
          <a:graphicData uri="http://schemas.openxmlformats.org/drawingml/2006/table">
            <a:tbl>
              <a:tblPr/>
              <a:tblGrid>
                <a:gridCol w="1752480"/>
                <a:gridCol w="3657600"/>
              </a:tblGrid>
              <a:tr h="3128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PRIM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SEQUENCE (5’-3’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3128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LP-FW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TGGAGTATGAGAGTGACGAGA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124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LP-RE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ATGAAGTGGGAGTGCTTGTA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128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L1a-FW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GCAAGACAGTGATTGAATA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128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L1a-RE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ATGGAGGGAGTTTACAGGA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128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BFA1-FW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TATGTCCGCCACCAC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124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BFA1-RE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ACGAAGTGCCATAGTAGAGA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128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PDH-FW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AAGAGCACAAGAGGAAG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128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PDH-RE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AGGGGTCTACATGGCAAC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11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PN-FW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TCTGGGAGGGCTTGGTT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128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PN-RE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TGGTCCCGACGATGC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6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02T16:18:38Z</dcterms:created>
  <dc:creator>Anseth Group</dc:creator>
  <dc:description/>
  <dc:language>en-US</dc:language>
  <cp:lastModifiedBy>Lesley Winchester</cp:lastModifiedBy>
  <dcterms:modified xsi:type="dcterms:W3CDTF">2011-04-25T13:52:22Z</dcterms:modified>
  <cp:revision>695</cp:revision>
  <dc:subject/>
  <dc:title>Slide 1</dc:title>
</cp:coreProperties>
</file>